
<file path=[Content_Types].xml><?xml version="1.0" encoding="utf-8"?>
<Types xmlns="http://schemas.openxmlformats.org/package/2006/content-types"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66"/>
    <p:restoredTop sz="94694"/>
  </p:normalViewPr>
  <p:slideViewPr>
    <p:cSldViewPr snapToGrid="0">
      <p:cViewPr varScale="1">
        <p:scale>
          <a:sx n="117" d="100"/>
          <a:sy n="117" d="100"/>
        </p:scale>
        <p:origin x="9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263BC-57CB-2C77-404B-79E94661E3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739841-AB57-1DD3-8F3F-F34EE3C374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A8570D-BED6-9E3F-1901-103E7387C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EF2FF8-ED90-C7E9-B7D4-0F8C81A5C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CFB04F-BC2A-6742-E0CF-DCFD6B5FA1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05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CFD85-AD3F-209F-3EC3-F09676EEC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EF8C82-21B3-B069-4530-A00729C022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97FDBB-5E6D-BE34-B992-46F084B71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9071F2-D132-B08F-A21B-5B08B1486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810B9E-571C-698A-005A-964D2D2A1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89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A3663A-ABC4-D3E9-C1FF-6A6631EDDCB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AF5BA2-2777-F51B-BD8D-2E60706B2B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19D81-051F-8849-97B1-37D1C7251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268989-8934-D94A-9AE4-C891AB47C4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9DAFD4-5A51-3C7F-8D55-FA659DFCB7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210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C5D032-C419-3BC6-A593-39FCEB4D8C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28DCC3-CDFC-653E-9EFD-3AF3A4411E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C7C8E5-9E39-CC19-8EA6-1049DD77D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1B05C5-5964-6176-38E9-BC4CA58856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EF8DBE-8F11-B2FE-D26B-6849A4E44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096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50AA45-ADCC-7849-C885-5733BEFB92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BB2ED7-0959-4C70-DB79-741730BFF8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16B71-8A10-E9ED-B9A5-A5F61AEBD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CCA1C4-B402-A2FE-3494-4353502DB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6EC22-A328-4185-4516-783D38AE8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485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E67440-65A3-87FA-749C-339D28D40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480D30-D1EC-E649-4B78-5F0E6A5F38B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131923-2F18-EB1D-BD72-8FB813F350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7ECEFD-DE79-32E5-317A-4C57187C4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888847-23CC-6AF5-A051-C96BB945C1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E909A8-3062-8474-F826-B8087462E8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58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38095-84BC-D34F-AB6E-51B880EA3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E8D50C-B231-FBE0-EAD7-A877BCE4DA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6454D4-A297-50C7-DECD-C86FCCE9F4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995E9E-0BE8-4B56-55B8-E6F59476AA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F78CB5-EF35-2198-BA7F-07644A0DC5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3BD8FB-8CC7-1661-DDDE-A7705E461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58B57D-6432-A558-9823-D12004F8E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51C95CA-68B2-06D5-4072-1E0585A86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298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AF524-D32B-4C5E-466F-8097354022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970617-5C57-5BE9-528A-BE1527757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FD0A6E-008E-6D60-A30A-C3E4EFEC9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6228EA-2072-64E3-62F1-D8B0977351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400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24D425-BF1A-4CB6-5172-647CA92E42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1C63A9-AA4E-65FE-ACEA-DA9A4AB7EC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518A17-FE09-8655-462F-7E41AE9F6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59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67EEF-13F3-3D37-8943-9557E6F95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57AC48-5D2E-C32B-C354-2A77E659B3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786A5BB-E0E4-50F2-4410-993D3ED0E0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15D588-1633-3F99-9FC9-CC3D46E89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9A54C5-AEE3-BACD-FD8B-4C3C66308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ED3F19-441F-4313-3A83-D377696FA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7036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C8E0B-7581-93D2-F5C4-305DD4998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CE0677E-5103-5E3E-2B9E-E125633C27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71AB7E-B419-AFFF-8019-9017D13724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5295F3-9912-6788-1794-70C7535C3F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EF288D-AE2B-B524-D43F-31C81BBB6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ECC02E-6A98-6249-B6D0-93129BD34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334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F81F24-0298-C97B-190C-E15F45290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936B6B-CF3C-EB11-4C97-EDD7E6133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E1E5F2-A67F-B0A9-73AD-C356AA2BA5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9D7512-E7E1-4445-B58C-C6728389908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DF52AC-1D2E-8621-ED8F-C12FB591567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3D9671-5B16-3FAE-B4E3-DDF93E5A41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F8FCEAE-FB0F-3141-95FB-57A088C7B2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710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ov"/><Relationship Id="rId1" Type="http://schemas.microsoft.com/office/2007/relationships/media" Target="../media/media2.mov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ov"/><Relationship Id="rId1" Type="http://schemas.microsoft.com/office/2007/relationships/media" Target="../media/media3.mov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4.mov"/><Relationship Id="rId1" Type="http://schemas.microsoft.com/office/2007/relationships/media" Target="../media/media4.mov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5.mov"/><Relationship Id="rId1" Type="http://schemas.microsoft.com/office/2007/relationships/media" Target="../media/media5.mov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6D269-0A34-D557-724F-08FFE4EECB6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PilU conformations</a:t>
            </a:r>
          </a:p>
        </p:txBody>
      </p:sp>
    </p:spTree>
    <p:extLst>
      <p:ext uri="{BB962C8B-B14F-4D97-AF65-F5344CB8AC3E}">
        <p14:creationId xmlns:p14="http://schemas.microsoft.com/office/powerpoint/2010/main" val="1974596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4326_trim">
            <a:hlinkClick r:id="" action="ppaction://media"/>
            <a:extLst>
              <a:ext uri="{FF2B5EF4-FFF2-40B4-BE49-F238E27FC236}">
                <a16:creationId xmlns:a16="http://schemas.microsoft.com/office/drawing/2014/main" id="{368D2A81-43E7-8E96-4014-9A0C09D2AD23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822886" y="939456"/>
            <a:ext cx="6546227" cy="523274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E816AFD-132D-BBCC-B0E2-49EBD938EAD2}"/>
              </a:ext>
            </a:extLst>
          </p:cNvPr>
          <p:cNvSpPr txBox="1"/>
          <p:nvPr/>
        </p:nvSpPr>
        <p:spPr>
          <a:xfrm>
            <a:off x="1621971" y="362634"/>
            <a:ext cx="257294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orph</a:t>
            </a:r>
          </a:p>
          <a:p>
            <a:r>
              <a:rPr lang="en-US" b="1" dirty="0"/>
              <a:t>Form 1 -&gt; 4 -&gt; 3 -&gt; 2 -&gt; 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2C2D8DC-7F18-6533-AA62-7928CF1E474E}"/>
              </a:ext>
            </a:extLst>
          </p:cNvPr>
          <p:cNvSpPr txBox="1"/>
          <p:nvPr/>
        </p:nvSpPr>
        <p:spPr>
          <a:xfrm>
            <a:off x="98855" y="177968"/>
            <a:ext cx="1116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ovie S1</a:t>
            </a:r>
          </a:p>
        </p:txBody>
      </p:sp>
    </p:spTree>
    <p:extLst>
      <p:ext uri="{BB962C8B-B14F-4D97-AF65-F5344CB8AC3E}">
        <p14:creationId xmlns:p14="http://schemas.microsoft.com/office/powerpoint/2010/main" val="57361059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3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mp0_trim">
            <a:hlinkClick r:id="" action="ppaction://media"/>
            <a:extLst>
              <a:ext uri="{FF2B5EF4-FFF2-40B4-BE49-F238E27FC236}">
                <a16:creationId xmlns:a16="http://schemas.microsoft.com/office/drawing/2014/main" id="{095E5D84-C24B-4E75-7E84-B6AE4FEEE49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l="8444" r="12405" b="4204"/>
          <a:stretch>
            <a:fillRect/>
          </a:stretch>
        </p:blipFill>
        <p:spPr>
          <a:xfrm>
            <a:off x="3121338" y="895914"/>
            <a:ext cx="5949324" cy="524198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29BB9AE-3748-C62C-B77F-9B5E9CC5DE3E}"/>
              </a:ext>
            </a:extLst>
          </p:cNvPr>
          <p:cNvSpPr txBox="1"/>
          <p:nvPr/>
        </p:nvSpPr>
        <p:spPr>
          <a:xfrm>
            <a:off x="936171" y="526582"/>
            <a:ext cx="2168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DVA component 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1C79D54-0A9E-41AD-CB3E-878B876F6F9C}"/>
              </a:ext>
            </a:extLst>
          </p:cNvPr>
          <p:cNvSpPr txBox="1"/>
          <p:nvPr/>
        </p:nvSpPr>
        <p:spPr>
          <a:xfrm>
            <a:off x="98855" y="177968"/>
            <a:ext cx="1116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ovie S2</a:t>
            </a:r>
          </a:p>
        </p:txBody>
      </p:sp>
    </p:spTree>
    <p:extLst>
      <p:ext uri="{BB962C8B-B14F-4D97-AF65-F5344CB8AC3E}">
        <p14:creationId xmlns:p14="http://schemas.microsoft.com/office/powerpoint/2010/main" val="20196329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46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mp1_trim">
            <a:hlinkClick r:id="" action="ppaction://media"/>
            <a:extLst>
              <a:ext uri="{FF2B5EF4-FFF2-40B4-BE49-F238E27FC236}">
                <a16:creationId xmlns:a16="http://schemas.microsoft.com/office/drawing/2014/main" id="{33D2FD5A-5CF4-E88C-8D6E-2B6CD14AC6E2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l="21443" t="20976" r="27713" b="17486"/>
          <a:stretch>
            <a:fillRect/>
          </a:stretch>
        </p:blipFill>
        <p:spPr>
          <a:xfrm>
            <a:off x="3262023" y="1059199"/>
            <a:ext cx="5949324" cy="52419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4F0BD35-0E32-D7A7-AE3D-1ED60B9F43BD}"/>
              </a:ext>
            </a:extLst>
          </p:cNvPr>
          <p:cNvSpPr txBox="1"/>
          <p:nvPr/>
        </p:nvSpPr>
        <p:spPr>
          <a:xfrm>
            <a:off x="936171" y="526582"/>
            <a:ext cx="2168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DVA component 1</a:t>
            </a:r>
          </a:p>
        </p:txBody>
      </p:sp>
    </p:spTree>
    <p:extLst>
      <p:ext uri="{BB962C8B-B14F-4D97-AF65-F5344CB8AC3E}">
        <p14:creationId xmlns:p14="http://schemas.microsoft.com/office/powerpoint/2010/main" val="321540374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42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mp2_trim">
            <a:hlinkClick r:id="" action="ppaction://media"/>
            <a:extLst>
              <a:ext uri="{FF2B5EF4-FFF2-40B4-BE49-F238E27FC236}">
                <a16:creationId xmlns:a16="http://schemas.microsoft.com/office/drawing/2014/main" id="{01387D65-866F-619C-EA28-921C24B3403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l="12105" t="8711" r="23866" b="13794"/>
          <a:stretch>
            <a:fillRect/>
          </a:stretch>
        </p:blipFill>
        <p:spPr>
          <a:xfrm>
            <a:off x="3454274" y="1093499"/>
            <a:ext cx="5949324" cy="52419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B989584-331E-A60C-DF03-AD5F24879AC9}"/>
              </a:ext>
            </a:extLst>
          </p:cNvPr>
          <p:cNvSpPr txBox="1"/>
          <p:nvPr/>
        </p:nvSpPr>
        <p:spPr>
          <a:xfrm>
            <a:off x="936171" y="526582"/>
            <a:ext cx="21683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DVA component 2</a:t>
            </a:r>
          </a:p>
        </p:txBody>
      </p:sp>
    </p:spTree>
    <p:extLst>
      <p:ext uri="{BB962C8B-B14F-4D97-AF65-F5344CB8AC3E}">
        <p14:creationId xmlns:p14="http://schemas.microsoft.com/office/powerpoint/2010/main" val="18164361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7862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4ACDF9F-3697-7157-0C74-18E0B95AFD88}"/>
              </a:ext>
            </a:extLst>
          </p:cNvPr>
          <p:cNvSpPr txBox="1"/>
          <p:nvPr/>
        </p:nvSpPr>
        <p:spPr>
          <a:xfrm>
            <a:off x="1621971" y="362634"/>
            <a:ext cx="29913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orph</a:t>
            </a:r>
          </a:p>
          <a:p>
            <a:r>
              <a:rPr lang="en-US" b="1" dirty="0"/>
              <a:t>Form 1 -&gt; 4 -&gt; 3 -&gt; 2 -&gt; 6 -&gt; 5</a:t>
            </a:r>
          </a:p>
        </p:txBody>
      </p:sp>
      <p:pic>
        <p:nvPicPr>
          <p:cNvPr id="8" name="143265_trim">
            <a:hlinkClick r:id="" action="ppaction://media"/>
            <a:extLst>
              <a:ext uri="{FF2B5EF4-FFF2-40B4-BE49-F238E27FC236}">
                <a16:creationId xmlns:a16="http://schemas.microsoft.com/office/drawing/2014/main" id="{C0E53A84-B7A2-7680-DC5C-9F7D78825A2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rcRect r="2762" b="2762"/>
          <a:stretch>
            <a:fillRect/>
          </a:stretch>
        </p:blipFill>
        <p:spPr>
          <a:xfrm>
            <a:off x="2822886" y="1262622"/>
            <a:ext cx="6546227" cy="523274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2CB839C-7618-E22C-71E9-2C5A46ABA3E0}"/>
              </a:ext>
            </a:extLst>
          </p:cNvPr>
          <p:cNvSpPr txBox="1"/>
          <p:nvPr/>
        </p:nvSpPr>
        <p:spPr>
          <a:xfrm>
            <a:off x="98855" y="177968"/>
            <a:ext cx="1116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Movie S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8422083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733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41</Words>
  <Application>Microsoft Macintosh PowerPoint</Application>
  <PresentationFormat>Widescreen</PresentationFormat>
  <Paragraphs>11</Paragraphs>
  <Slides>6</Slides>
  <Notes>0</Notes>
  <HiddenSlides>0</HiddenSlides>
  <MMClips>5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Office Theme</vt:lpstr>
      <vt:lpstr>PilU conformation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irui Guo</dc:creator>
  <cp:lastModifiedBy>Yirui Guo</cp:lastModifiedBy>
  <cp:revision>14</cp:revision>
  <dcterms:created xsi:type="dcterms:W3CDTF">2025-12-01T23:52:21Z</dcterms:created>
  <dcterms:modified xsi:type="dcterms:W3CDTF">2026-04-01T20:25:57Z</dcterms:modified>
</cp:coreProperties>
</file>